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7F4EE-383A-436A-9E9D-6C8A5F8748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1ADB7-FC5D-462C-9DBB-C9EFF502BD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EB823-4D38-467B-AAF4-FA8099F2D2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66F0B-236A-4414-B792-1591212A1D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22BAF-DBBF-4442-A68A-B8DE062D66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FB25B-CD20-4D60-ABE5-E25B18199F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7AF9D-DE4B-4CED-ACF7-076BD3B8A9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7560CD-855E-4670-8455-BA69FB2AF7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B2D6F-7B4A-4E32-B38C-9D151F173A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7803CA-3BBD-4CBB-8293-96840698E8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2A61A-B040-46B6-830D-3C322B7961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C8542-DD1E-4C53-A460-9CE5E28711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15BF2B-0BAA-469E-A7C6-5BA7CE12EB95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2868480" y="404640"/>
            <a:ext cx="12012480" cy="5859000"/>
            <a:chOff x="-2868480" y="404640"/>
            <a:chExt cx="12012480" cy="5859000"/>
          </a:xfrm>
        </p:grpSpPr>
        <p:grpSp>
          <p:nvGrpSpPr>
            <p:cNvPr id="42" name=""/>
            <p:cNvGrpSpPr/>
            <p:nvPr/>
          </p:nvGrpSpPr>
          <p:grpSpPr>
            <a:xfrm>
              <a:off x="-2868480" y="404640"/>
              <a:ext cx="12012480" cy="5859000"/>
              <a:chOff x="-2868480" y="404640"/>
              <a:chExt cx="12012480" cy="5859000"/>
            </a:xfrm>
          </p:grpSpPr>
          <p:sp>
            <p:nvSpPr>
              <p:cNvPr id="43" name=""/>
              <p:cNvSpPr/>
              <p:nvPr/>
            </p:nvSpPr>
            <p:spPr>
              <a:xfrm>
                <a:off x="-2863440" y="404640"/>
                <a:ext cx="7191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Table 1. Expression of AFP, AFPR and Src in clinical patients’ liver tissues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-1160640" y="934560"/>
                <a:ext cx="2026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Normal liver tissue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-1122840" y="1274400"/>
                <a:ext cx="194400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HBV(-)     HBV(+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(n= 6 )       (n= 0 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-1114200" y="1274400"/>
                <a:ext cx="194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289880" y="912600"/>
                <a:ext cx="2154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Hepatitis liver tissue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400400" y="1261800"/>
                <a:ext cx="194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829880" y="1266480"/>
                <a:ext cx="805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(n=1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3689280" y="880560"/>
                <a:ext cx="222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Cirrhosis liver tissues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3803760" y="1215720"/>
                <a:ext cx="1944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824280" y="1193400"/>
                <a:ext cx="206856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HBV(-)       HBV(+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(n=4)          (n=17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6432840" y="887040"/>
                <a:ext cx="17960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HCC liver tissue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6380280" y="1215720"/>
                <a:ext cx="1944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6318360" y="1199880"/>
                <a:ext cx="238752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HBV(-)        HBV(+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(n=8)           (n=22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-2731680" y="1955520"/>
                <a:ext cx="125352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Serum AFP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    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(ng/ml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-2715480" y="2619000"/>
                <a:ext cx="1128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IH stained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8" name=""/>
              <p:cNvGrpSpPr/>
              <p:nvPr/>
            </p:nvGrpSpPr>
            <p:grpSpPr>
              <a:xfrm>
                <a:off x="-2332800" y="2884320"/>
                <a:ext cx="1009080" cy="826920"/>
                <a:chOff x="-2332800" y="2884320"/>
                <a:chExt cx="1009080" cy="826920"/>
              </a:xfrm>
            </p:grpSpPr>
            <p:sp>
              <p:nvSpPr>
                <p:cNvPr id="59" name=""/>
                <p:cNvSpPr/>
                <p:nvPr/>
              </p:nvSpPr>
              <p:spPr>
                <a:xfrm>
                  <a:off x="-2332800" y="3128760"/>
                  <a:ext cx="5983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</a:rPr>
                    <a:t>AFP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-1795320" y="3066840"/>
                  <a:ext cx="69840" cy="503280"/>
                </a:xfrm>
                <a:custGeom>
                  <a:avLst/>
                  <a:gdLst>
                    <a:gd name="textAreaLeft" fmla="*/ 44640 w 69840"/>
                    <a:gd name="textAreaRight" fmla="*/ 69840 w 69840"/>
                    <a:gd name="textAreaTop" fmla="*/ 12960 h 503280"/>
                    <a:gd name="textAreaBottom" fmla="*/ 490320 h 50328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-1785960" y="2884320"/>
                  <a:ext cx="4093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</a:rPr>
                    <a:t>(-)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-1786320" y="3342960"/>
                  <a:ext cx="4626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</a:rPr>
                    <a:t>(+)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3" name=""/>
              <p:cNvGrpSpPr/>
              <p:nvPr/>
            </p:nvGrpSpPr>
            <p:grpSpPr>
              <a:xfrm>
                <a:off x="-2477160" y="3760560"/>
                <a:ext cx="1142280" cy="826920"/>
                <a:chOff x="-2477160" y="3760560"/>
                <a:chExt cx="1142280" cy="826920"/>
              </a:xfrm>
            </p:grpSpPr>
            <p:sp>
              <p:nvSpPr>
                <p:cNvPr id="64" name=""/>
                <p:cNvSpPr/>
                <p:nvPr/>
              </p:nvSpPr>
              <p:spPr>
                <a:xfrm>
                  <a:off x="-2477160" y="4005000"/>
                  <a:ext cx="7506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</a:rPr>
                    <a:t>AFPR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-1806480" y="3943080"/>
                  <a:ext cx="69840" cy="503280"/>
                </a:xfrm>
                <a:custGeom>
                  <a:avLst/>
                  <a:gdLst>
                    <a:gd name="textAreaLeft" fmla="*/ 44640 w 69840"/>
                    <a:gd name="textAreaRight" fmla="*/ 69840 w 69840"/>
                    <a:gd name="textAreaTop" fmla="*/ 12960 h 503280"/>
                    <a:gd name="textAreaBottom" fmla="*/ 490320 h 50328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-1796760" y="3760560"/>
                  <a:ext cx="4093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</a:rPr>
                    <a:t>(-)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-1797480" y="4219200"/>
                  <a:ext cx="4626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</a:rPr>
                    <a:t>(+)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8" name=""/>
              <p:cNvGrpSpPr/>
              <p:nvPr/>
            </p:nvGrpSpPr>
            <p:grpSpPr>
              <a:xfrm>
                <a:off x="-2265480" y="4646160"/>
                <a:ext cx="902160" cy="827280"/>
                <a:chOff x="-2265480" y="4646160"/>
                <a:chExt cx="902160" cy="827280"/>
              </a:xfrm>
            </p:grpSpPr>
            <p:sp>
              <p:nvSpPr>
                <p:cNvPr id="69" name=""/>
                <p:cNvSpPr/>
                <p:nvPr/>
              </p:nvSpPr>
              <p:spPr>
                <a:xfrm>
                  <a:off x="-2265480" y="4865400"/>
                  <a:ext cx="4856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800" spc="-1" strike="noStrike">
                      <a:solidFill>
                        <a:srgbClr val="000000"/>
                      </a:solidFill>
                      <a:latin typeface="Times New Roman"/>
                    </a:rPr>
                    <a:t>Src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-1834920" y="4828680"/>
                  <a:ext cx="69840" cy="503280"/>
                </a:xfrm>
                <a:custGeom>
                  <a:avLst/>
                  <a:gdLst>
                    <a:gd name="textAreaLeft" fmla="*/ 44640 w 69840"/>
                    <a:gd name="textAreaRight" fmla="*/ 69840 w 69840"/>
                    <a:gd name="textAreaTop" fmla="*/ 12960 h 503280"/>
                    <a:gd name="textAreaBottom" fmla="*/ 490320 h 50328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"/>
                <p:cNvSpPr/>
                <p:nvPr/>
              </p:nvSpPr>
              <p:spPr>
                <a:xfrm>
                  <a:off x="-1825560" y="4646160"/>
                  <a:ext cx="4093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</a:rPr>
                    <a:t>(-)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>
                  <a:off x="-1825920" y="5105160"/>
                  <a:ext cx="4626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Times New Roman"/>
                    </a:rPr>
                    <a:t>(+)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3" name=""/>
              <p:cNvSpPr/>
              <p:nvPr/>
            </p:nvSpPr>
            <p:spPr>
              <a:xfrm>
                <a:off x="-1263600" y="1971360"/>
                <a:ext cx="935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8.5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</a:t>
                </a: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4.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825560" y="2004840"/>
                <a:ext cx="10508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800" spc="-1" strike="noStrike">
                    <a:solidFill>
                      <a:srgbClr val="000000"/>
                    </a:solidFill>
                    <a:latin typeface="Times New Roman"/>
                  </a:rPr>
                  <a:t>22.6±9.8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862520" y="1988640"/>
                <a:ext cx="1165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800" spc="-1" strike="noStrike">
                    <a:solidFill>
                      <a:srgbClr val="000000"/>
                    </a:solidFill>
                    <a:latin typeface="Times New Roman"/>
                  </a:rPr>
                  <a:t>58.9±38.7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3609720" y="1990440"/>
                <a:ext cx="1165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800" spc="-1" strike="noStrike">
                    <a:solidFill>
                      <a:srgbClr val="000000"/>
                    </a:solidFill>
                    <a:latin typeface="Times New Roman"/>
                  </a:rPr>
                  <a:t>19.7±16.8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6257520" y="2003040"/>
                <a:ext cx="1222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800" spc="-1" strike="noStrike">
                    <a:solidFill>
                      <a:srgbClr val="000000"/>
                    </a:solidFill>
                    <a:latin typeface="Times New Roman"/>
                  </a:rPr>
                  <a:t>40.1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±27.5 </a:t>
                </a:r>
                <a:r>
                  <a:rPr b="0" lang="it-IT" sz="18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7434360" y="1990440"/>
                <a:ext cx="1279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800" spc="-1" strike="noStrike">
                    <a:solidFill>
                      <a:srgbClr val="000000"/>
                    </a:solidFill>
                    <a:latin typeface="Times New Roman"/>
                  </a:rPr>
                  <a:t>201.3±45.4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-2809800" y="855360"/>
                <a:ext cx="11880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-2824200" y="1917360"/>
                <a:ext cx="11881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-1325520" y="2866680"/>
                <a:ext cx="1159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100%(6/6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-1247760" y="3327120"/>
                <a:ext cx="930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0%(0/6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-1338480" y="3808080"/>
                <a:ext cx="1159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100%(6/6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-1274760" y="4228920"/>
                <a:ext cx="930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0%(0/6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-1287720" y="5130360"/>
                <a:ext cx="930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0%(0/6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-1390680" y="4654080"/>
                <a:ext cx="1159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100%(6/6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688760" y="336204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42.8%(6/1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702800" y="283968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57.2%(8/1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701360" y="377964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50.0%(7/1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1702800" y="423828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50.0%(7/1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1686960" y="4714560"/>
                <a:ext cx="1445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71.4%(10/1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1701360" y="515916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28.6%(4/1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3558600" y="284292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25.0%(1/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3546000" y="332856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75.0%(3/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3558600" y="376992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25.0%(1/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547440" y="425736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75.0%(3/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566520" y="469404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50.0%(2/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568320" y="516384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50.0%(2/4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809600" y="284436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29.4%(5/17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825440" y="3330360"/>
                <a:ext cx="1445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70.6%(12/17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4836600" y="378900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23.5%(4/17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4838040" y="4246200"/>
                <a:ext cx="1445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75.5%(13/17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838400" y="471600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47.1%(8/17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4852440" y="517320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52.9%(9/17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6231960" y="284436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25.0%(2/8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6247800" y="333036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75.0%(6/8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6239880" y="379368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37.5%(3/8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6247800" y="425880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62.5%(5/8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6222600" y="473040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37.5%(3/8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6239880" y="517176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62.5%(5/8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7425720" y="283176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13.6%(3/22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7413120" y="3330360"/>
                <a:ext cx="1445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86.4%(19/22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7417800" y="3812760"/>
                <a:ext cx="1217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9.1%(2/22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7405200" y="4257360"/>
                <a:ext cx="1445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90.9%(20/22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7405200" y="4723920"/>
                <a:ext cx="1331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36.4%(8/22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7419240" y="5168520"/>
                <a:ext cx="14457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63.6%(14/22)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-2808360" y="5547960"/>
                <a:ext cx="11881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-2868480" y="1553760"/>
                <a:ext cx="16131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Times New Roman"/>
                  </a:rPr>
                  <a:t>Analyzed item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-2805120" y="5621040"/>
                <a:ext cx="1193796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Note: 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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  represent non data; *</a:t>
                </a:r>
                <a:r>
                  <a:rPr b="0" i="1" lang="zh-CN" sz="1800" spc="-1" strike="noStrike">
                    <a:solidFill>
                      <a:srgbClr val="000000"/>
                    </a:solidFill>
                    <a:latin typeface="Times New Roman"/>
                  </a:rPr>
                  <a:t>P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&lt;0.05, vs Src(+) groups; **</a:t>
                </a:r>
                <a:r>
                  <a:rPr b="0" i="1" lang="zh-CN" sz="1800" spc="-1" strike="noStrike">
                    <a:solidFill>
                      <a:srgbClr val="000000"/>
                    </a:solidFill>
                    <a:latin typeface="Times New Roman"/>
                  </a:rPr>
                  <a:t>P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&lt;0.01, vs Src(+) groups; </a:t>
                </a:r>
                <a:r>
                  <a:rPr b="0" lang="zh-CN" sz="1800" spc="-1" strike="noStrike" baseline="30000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0" i="1" lang="zh-CN" sz="1800" spc="-1" strike="noStrike">
                    <a:solidFill>
                      <a:srgbClr val="000000"/>
                    </a:solidFill>
                    <a:latin typeface="Times New Roman"/>
                  </a:rPr>
                  <a:t>P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&lt;0.01 vs Src(+) groups,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Statistical significance was determined using the 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MingLiU"/>
                    <a:ea typeface="MingLiU"/>
                  </a:rPr>
                  <a:t>x</a:t>
                </a:r>
                <a:r>
                  <a:rPr b="0" lang="zh-CN" sz="1800" spc="-1" strike="noStrike" baseline="30000">
                    <a:solidFill>
                      <a:srgbClr val="000000"/>
                    </a:solidFill>
                    <a:latin typeface="MingLiU"/>
                    <a:ea typeface="MingLiU"/>
                  </a:rPr>
                  <a:t>2</a:t>
                </a:r>
                <a:r>
                  <a:rPr b="0" i="1" lang="zh-CN" sz="18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test (SPSS 11.5 software). 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111240" y="1990440"/>
                <a:ext cx="218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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111240" y="2876400"/>
                <a:ext cx="218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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100080" y="3335040"/>
                <a:ext cx="218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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112680" y="3831840"/>
                <a:ext cx="218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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123840" y="4236840"/>
                <a:ext cx="218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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111240" y="4679640"/>
                <a:ext cx="218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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123840" y="5151240"/>
                <a:ext cx="218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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840040" y="3331800"/>
                <a:ext cx="295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881080" y="4246200"/>
                <a:ext cx="295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6062760" y="3242880"/>
                <a:ext cx="295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6089760" y="4144680"/>
                <a:ext cx="295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8680680" y="3303360"/>
                <a:ext cx="463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8666280" y="4233600"/>
                <a:ext cx="463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3" name=""/>
            <p:cNvSpPr/>
            <p:nvPr/>
          </p:nvSpPr>
          <p:spPr>
            <a:xfrm>
              <a:off x="7246800" y="4670280"/>
              <a:ext cx="320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8551800" y="4665600"/>
              <a:ext cx="320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962080" y="4656240"/>
              <a:ext cx="320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9-23T07:15:19Z</dcterms:created>
  <dc:creator>李天盟(tml@qq.com)</dc:creator>
  <dc:description/>
  <dc:language>en-US</dc:language>
  <cp:lastModifiedBy>李天盟(tml@qq.com)</cp:lastModifiedBy>
  <dcterms:modified xsi:type="dcterms:W3CDTF">2015-02-27T10:33:18Z</dcterms:modified>
  <cp:revision>39</cp:revision>
  <dc:subject/>
  <dc:title>幻灯片 1</dc:title>
</cp:coreProperties>
</file>